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2" r:id="rId3"/>
    <p:sldId id="263" r:id="rId4"/>
    <p:sldId id="261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77" y="55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EB4-9BA6-4FD2-BA0C-780DD29ABBB0}" type="datetimeFigureOut">
              <a:rPr lang="en-US" smtClean="0"/>
              <a:t>10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46611-5D22-4F31-A2BE-21B8E94859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81215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EB4-9BA6-4FD2-BA0C-780DD29ABBB0}" type="datetimeFigureOut">
              <a:rPr lang="en-US" smtClean="0"/>
              <a:t>10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46611-5D22-4F31-A2BE-21B8E94859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23108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EB4-9BA6-4FD2-BA0C-780DD29ABBB0}" type="datetimeFigureOut">
              <a:rPr lang="en-US" smtClean="0"/>
              <a:t>10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46611-5D22-4F31-A2BE-21B8E94859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44482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EB4-9BA6-4FD2-BA0C-780DD29ABBB0}" type="datetimeFigureOut">
              <a:rPr lang="en-US" smtClean="0"/>
              <a:t>10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46611-5D22-4F31-A2BE-21B8E94859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75002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EB4-9BA6-4FD2-BA0C-780DD29ABBB0}" type="datetimeFigureOut">
              <a:rPr lang="en-US" smtClean="0"/>
              <a:t>10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46611-5D22-4F31-A2BE-21B8E94859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64516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EB4-9BA6-4FD2-BA0C-780DD29ABBB0}" type="datetimeFigureOut">
              <a:rPr lang="en-US" smtClean="0"/>
              <a:t>10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46611-5D22-4F31-A2BE-21B8E94859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51070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EB4-9BA6-4FD2-BA0C-780DD29ABBB0}" type="datetimeFigureOut">
              <a:rPr lang="en-US" smtClean="0"/>
              <a:t>10/2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46611-5D22-4F31-A2BE-21B8E94859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67929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EB4-9BA6-4FD2-BA0C-780DD29ABBB0}" type="datetimeFigureOut">
              <a:rPr lang="en-US" smtClean="0"/>
              <a:t>10/2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46611-5D22-4F31-A2BE-21B8E94859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38338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EB4-9BA6-4FD2-BA0C-780DD29ABBB0}" type="datetimeFigureOut">
              <a:rPr lang="en-US" smtClean="0"/>
              <a:t>10/2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46611-5D22-4F31-A2BE-21B8E94859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67926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EB4-9BA6-4FD2-BA0C-780DD29ABBB0}" type="datetimeFigureOut">
              <a:rPr lang="en-US" smtClean="0"/>
              <a:t>10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46611-5D22-4F31-A2BE-21B8E94859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02667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EB4-9BA6-4FD2-BA0C-780DD29ABBB0}" type="datetimeFigureOut">
              <a:rPr lang="en-US" smtClean="0"/>
              <a:t>10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46611-5D22-4F31-A2BE-21B8E94859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80137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4F8EB4-9BA6-4FD2-BA0C-780DD29ABBB0}" type="datetimeFigureOut">
              <a:rPr lang="en-US" smtClean="0"/>
              <a:t>10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346611-5D22-4F31-A2BE-21B8E94859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43618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9.jpg"/><Relationship Id="rId3" Type="http://schemas.openxmlformats.org/officeDocument/2006/relationships/image" Target="../media/image2.png"/><Relationship Id="rId7" Type="http://schemas.microsoft.com/office/2007/relationships/hdphoto" Target="../media/hdphoto1.wdp"/><Relationship Id="rId12" Type="http://schemas.openxmlformats.org/officeDocument/2006/relationships/image" Target="../media/image8.jpg"/><Relationship Id="rId2" Type="http://schemas.openxmlformats.org/officeDocument/2006/relationships/image" Target="../media/image1.png"/><Relationship Id="rId16" Type="http://schemas.openxmlformats.org/officeDocument/2006/relationships/image" Target="../media/image12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microsoft.com/office/2007/relationships/hdphoto" Target="../media/hdphoto3.wdp"/><Relationship Id="rId5" Type="http://schemas.openxmlformats.org/officeDocument/2006/relationships/image" Target="../media/image4.png"/><Relationship Id="rId15" Type="http://schemas.openxmlformats.org/officeDocument/2006/relationships/image" Target="../media/image11.jpg"/><Relationship Id="rId10" Type="http://schemas.openxmlformats.org/officeDocument/2006/relationships/image" Target="../media/image7.png"/><Relationship Id="rId4" Type="http://schemas.openxmlformats.org/officeDocument/2006/relationships/image" Target="../media/image3.png"/><Relationship Id="rId9" Type="http://schemas.microsoft.com/office/2007/relationships/hdphoto" Target="../media/hdphoto2.wdp"/><Relationship Id="rId14" Type="http://schemas.openxmlformats.org/officeDocument/2006/relationships/image" Target="../media/image10.png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13" Type="http://schemas.microsoft.com/office/2007/relationships/hdphoto" Target="../media/hdphoto3.wdp"/><Relationship Id="rId3" Type="http://schemas.openxmlformats.org/officeDocument/2006/relationships/image" Target="../media/image14.png"/><Relationship Id="rId7" Type="http://schemas.openxmlformats.org/officeDocument/2006/relationships/image" Target="../media/image5.png"/><Relationship Id="rId12" Type="http://schemas.openxmlformats.org/officeDocument/2006/relationships/image" Target="../media/image7.png"/><Relationship Id="rId2" Type="http://schemas.openxmlformats.org/officeDocument/2006/relationships/image" Target="../media/image13.png"/><Relationship Id="rId16" Type="http://schemas.openxmlformats.org/officeDocument/2006/relationships/image" Target="../media/image2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png"/><Relationship Id="rId11" Type="http://schemas.openxmlformats.org/officeDocument/2006/relationships/image" Target="../media/image9.jpg"/><Relationship Id="rId5" Type="http://schemas.openxmlformats.org/officeDocument/2006/relationships/image" Target="../media/image16.png"/><Relationship Id="rId15" Type="http://schemas.openxmlformats.org/officeDocument/2006/relationships/image" Target="../media/image19.png"/><Relationship Id="rId10" Type="http://schemas.microsoft.com/office/2007/relationships/hdphoto" Target="../media/hdphoto2.wdp"/><Relationship Id="rId4" Type="http://schemas.openxmlformats.org/officeDocument/2006/relationships/image" Target="../media/image15.png"/><Relationship Id="rId9" Type="http://schemas.openxmlformats.org/officeDocument/2006/relationships/image" Target="../media/image6.png"/><Relationship Id="rId14" Type="http://schemas.openxmlformats.org/officeDocument/2006/relationships/image" Target="../media/image18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3" Type="http://schemas.microsoft.com/office/2007/relationships/hdphoto" Target="../media/hdphoto4.wdp"/><Relationship Id="rId7" Type="http://schemas.microsoft.com/office/2007/relationships/hdphoto" Target="../media/hdphoto6.wdp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png"/><Relationship Id="rId5" Type="http://schemas.microsoft.com/office/2007/relationships/hdphoto" Target="../media/hdphoto5.wdp"/><Relationship Id="rId4" Type="http://schemas.openxmlformats.org/officeDocument/2006/relationships/image" Target="../media/image22.png"/><Relationship Id="rId9" Type="http://schemas.microsoft.com/office/2007/relationships/hdphoto" Target="../media/hdphoto7.wdp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9.wdp"/><Relationship Id="rId13" Type="http://schemas.openxmlformats.org/officeDocument/2006/relationships/image" Target="../media/image34.png"/><Relationship Id="rId3" Type="http://schemas.openxmlformats.org/officeDocument/2006/relationships/image" Target="../media/image26.png"/><Relationship Id="rId7" Type="http://schemas.openxmlformats.org/officeDocument/2006/relationships/image" Target="../media/image29.png"/><Relationship Id="rId12" Type="http://schemas.openxmlformats.org/officeDocument/2006/relationships/image" Target="../media/image33.jpg"/><Relationship Id="rId2" Type="http://schemas.openxmlformats.org/officeDocument/2006/relationships/image" Target="../media/image25.jpg"/><Relationship Id="rId1" Type="http://schemas.openxmlformats.org/officeDocument/2006/relationships/slideLayout" Target="../slideLayouts/slideLayout2.xml"/><Relationship Id="rId6" Type="http://schemas.microsoft.com/office/2007/relationships/hdphoto" Target="../media/hdphoto8.wdp"/><Relationship Id="rId11" Type="http://schemas.openxmlformats.org/officeDocument/2006/relationships/image" Target="../media/image32.png"/><Relationship Id="rId5" Type="http://schemas.openxmlformats.org/officeDocument/2006/relationships/image" Target="../media/image28.png"/><Relationship Id="rId15" Type="http://schemas.openxmlformats.org/officeDocument/2006/relationships/image" Target="../media/image36.png"/><Relationship Id="rId10" Type="http://schemas.openxmlformats.org/officeDocument/2006/relationships/image" Target="../media/image31.png"/><Relationship Id="rId4" Type="http://schemas.openxmlformats.org/officeDocument/2006/relationships/image" Target="../media/image27.jpg"/><Relationship Id="rId9" Type="http://schemas.openxmlformats.org/officeDocument/2006/relationships/image" Target="../media/image30.png"/><Relationship Id="rId14" Type="http://schemas.openxmlformats.org/officeDocument/2006/relationships/image" Target="../media/image3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flipH="1">
            <a:off x="7234774" y="5557636"/>
            <a:ext cx="4516334" cy="1054521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7235601" y="4513996"/>
            <a:ext cx="4419184" cy="1022645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125930" y="2383791"/>
            <a:ext cx="4593673" cy="1118343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393604" y="751912"/>
            <a:ext cx="4559915" cy="758648"/>
          </a:xfrm>
          <a:prstGeom prst="rect">
            <a:avLst/>
          </a:prstGeom>
        </p:spPr>
      </p:pic>
      <p:pic>
        <p:nvPicPr>
          <p:cNvPr id="85" name="Picture 84"/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248" t="57182" r="29286" b="29897"/>
          <a:stretch/>
        </p:blipFill>
        <p:spPr>
          <a:xfrm flipH="1">
            <a:off x="1348975" y="4731716"/>
            <a:ext cx="4626927" cy="1153664"/>
          </a:xfrm>
          <a:prstGeom prst="rect">
            <a:avLst/>
          </a:prstGeom>
        </p:spPr>
      </p:pic>
      <p:sp>
        <p:nvSpPr>
          <p:cNvPr id="86" name="TextBox 85"/>
          <p:cNvSpPr txBox="1"/>
          <p:nvPr/>
        </p:nvSpPr>
        <p:spPr>
          <a:xfrm>
            <a:off x="1624823" y="4765215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1598721" y="5187906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8478" t="20069" r="29285" b="72234"/>
          <a:stretch/>
        </p:blipFill>
        <p:spPr>
          <a:xfrm flipH="1">
            <a:off x="1337057" y="3996596"/>
            <a:ext cx="4627789" cy="674886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578" t="39588" r="29835" b="48728"/>
          <a:stretch/>
        </p:blipFill>
        <p:spPr>
          <a:xfrm flipH="1">
            <a:off x="7075647" y="1326784"/>
            <a:ext cx="4587901" cy="1056833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488" t="23780" r="30055" b="64673"/>
          <a:stretch/>
        </p:blipFill>
        <p:spPr>
          <a:xfrm flipH="1">
            <a:off x="7144580" y="3534789"/>
            <a:ext cx="4510205" cy="981497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379" t="16632" r="30055" b="75670"/>
          <a:stretch/>
        </p:blipFill>
        <p:spPr>
          <a:xfrm flipH="1">
            <a:off x="7031045" y="620671"/>
            <a:ext cx="4632503" cy="670335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 flipH="1">
            <a:off x="1329272" y="2263797"/>
            <a:ext cx="4624247" cy="964533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421" t="37801" r="30610" b="52027"/>
          <a:stretch/>
        </p:blipFill>
        <p:spPr>
          <a:xfrm>
            <a:off x="1361917" y="1551651"/>
            <a:ext cx="2917538" cy="678925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329" t="47560" r="29070" b="41216"/>
          <a:stretch/>
        </p:blipFill>
        <p:spPr>
          <a:xfrm>
            <a:off x="1367526" y="3267398"/>
            <a:ext cx="2911929" cy="660255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2410991" y="1144780"/>
            <a:ext cx="1568789" cy="26167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TextBox 42"/>
          <p:cNvSpPr txBox="1"/>
          <p:nvPr/>
        </p:nvSpPr>
        <p:spPr>
          <a:xfrm>
            <a:off x="526193" y="1177553"/>
            <a:ext cx="9028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DUFS1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Rectangle 43"/>
          <p:cNvSpPr/>
          <p:nvPr/>
        </p:nvSpPr>
        <p:spPr>
          <a:xfrm>
            <a:off x="1836342" y="1906098"/>
            <a:ext cx="1045149" cy="28630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TextBox 44"/>
          <p:cNvSpPr txBox="1"/>
          <p:nvPr/>
        </p:nvSpPr>
        <p:spPr>
          <a:xfrm>
            <a:off x="574601" y="1703046"/>
            <a:ext cx="8512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T-ND1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6402065" y="2991047"/>
            <a:ext cx="6735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OX4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Rectangle 46"/>
          <p:cNvSpPr/>
          <p:nvPr/>
        </p:nvSpPr>
        <p:spPr>
          <a:xfrm>
            <a:off x="8051079" y="2942978"/>
            <a:ext cx="1617175" cy="29905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Rectangle 47"/>
          <p:cNvSpPr/>
          <p:nvPr/>
        </p:nvSpPr>
        <p:spPr>
          <a:xfrm>
            <a:off x="9882287" y="4087135"/>
            <a:ext cx="904974" cy="3077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TextBox 48"/>
          <p:cNvSpPr txBox="1"/>
          <p:nvPr/>
        </p:nvSpPr>
        <p:spPr>
          <a:xfrm>
            <a:off x="6374724" y="3978301"/>
            <a:ext cx="8608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T-CO2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6190867" y="1805078"/>
            <a:ext cx="8624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T-CYB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Rectangle 50"/>
          <p:cNvSpPr/>
          <p:nvPr/>
        </p:nvSpPr>
        <p:spPr>
          <a:xfrm>
            <a:off x="9968568" y="2077565"/>
            <a:ext cx="934598" cy="2758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Rectangle 51"/>
          <p:cNvSpPr/>
          <p:nvPr/>
        </p:nvSpPr>
        <p:spPr>
          <a:xfrm>
            <a:off x="4285042" y="5213613"/>
            <a:ext cx="904486" cy="28206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TextBox 52"/>
          <p:cNvSpPr txBox="1"/>
          <p:nvPr/>
        </p:nvSpPr>
        <p:spPr>
          <a:xfrm>
            <a:off x="562888" y="4980541"/>
            <a:ext cx="7777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TOM2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6090145" y="863786"/>
            <a:ext cx="9428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UQCRC2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Rectangle 55"/>
          <p:cNvSpPr/>
          <p:nvPr/>
        </p:nvSpPr>
        <p:spPr>
          <a:xfrm>
            <a:off x="9847364" y="864978"/>
            <a:ext cx="886120" cy="2850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TextBox 57"/>
          <p:cNvSpPr txBox="1"/>
          <p:nvPr/>
        </p:nvSpPr>
        <p:spPr>
          <a:xfrm>
            <a:off x="647127" y="2592233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DH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Rectangle 58"/>
          <p:cNvSpPr/>
          <p:nvPr/>
        </p:nvSpPr>
        <p:spPr>
          <a:xfrm>
            <a:off x="4538174" y="2896452"/>
            <a:ext cx="1056589" cy="2232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TextBox 59"/>
          <p:cNvSpPr txBox="1"/>
          <p:nvPr/>
        </p:nvSpPr>
        <p:spPr>
          <a:xfrm>
            <a:off x="4185829" y="1646181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1566653" y="2585303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1576549" y="2307200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450302" y="3379077"/>
            <a:ext cx="9714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AM210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Rectangle 68"/>
          <p:cNvSpPr/>
          <p:nvPr/>
        </p:nvSpPr>
        <p:spPr>
          <a:xfrm>
            <a:off x="2092741" y="3564248"/>
            <a:ext cx="917178" cy="21460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TextBox 69"/>
          <p:cNvSpPr txBox="1"/>
          <p:nvPr/>
        </p:nvSpPr>
        <p:spPr>
          <a:xfrm>
            <a:off x="4241004" y="3218432"/>
            <a:ext cx="421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4211753" y="3462477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4211272" y="3709001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556689" y="4164402"/>
            <a:ext cx="8242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Rectangle 74"/>
          <p:cNvSpPr/>
          <p:nvPr/>
        </p:nvSpPr>
        <p:spPr>
          <a:xfrm>
            <a:off x="4150777" y="4087242"/>
            <a:ext cx="993402" cy="29574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" name="TextBox 75"/>
          <p:cNvSpPr txBox="1"/>
          <p:nvPr/>
        </p:nvSpPr>
        <p:spPr>
          <a:xfrm>
            <a:off x="4211753" y="1886822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Rectangle 77"/>
          <p:cNvSpPr/>
          <p:nvPr/>
        </p:nvSpPr>
        <p:spPr>
          <a:xfrm>
            <a:off x="9705458" y="5935448"/>
            <a:ext cx="1772694" cy="3314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9" name="TextBox 78"/>
          <p:cNvSpPr txBox="1"/>
          <p:nvPr/>
        </p:nvSpPr>
        <p:spPr>
          <a:xfrm>
            <a:off x="6216890" y="5814805"/>
            <a:ext cx="9276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T-ATP6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Rectangle 81"/>
          <p:cNvSpPr/>
          <p:nvPr/>
        </p:nvSpPr>
        <p:spPr>
          <a:xfrm>
            <a:off x="7796576" y="5064542"/>
            <a:ext cx="1871678" cy="37433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TextBox 82"/>
          <p:cNvSpPr txBox="1"/>
          <p:nvPr/>
        </p:nvSpPr>
        <p:spPr>
          <a:xfrm>
            <a:off x="6338975" y="4726581"/>
            <a:ext cx="7403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TP5B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/>
          <p:cNvSpPr txBox="1"/>
          <p:nvPr/>
        </p:nvSpPr>
        <p:spPr>
          <a:xfrm rot="21533104">
            <a:off x="667456" y="6233734"/>
            <a:ext cx="1418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ample loading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Group 7"/>
          <p:cNvGrpSpPr/>
          <p:nvPr/>
        </p:nvGrpSpPr>
        <p:grpSpPr>
          <a:xfrm>
            <a:off x="2056611" y="6134935"/>
            <a:ext cx="2074561" cy="557006"/>
            <a:chOff x="2147893" y="5819251"/>
            <a:chExt cx="2074561" cy="557006"/>
          </a:xfrm>
        </p:grpSpPr>
        <p:sp>
          <p:nvSpPr>
            <p:cNvPr id="108" name="Rectangle 107"/>
            <p:cNvSpPr/>
            <p:nvPr/>
          </p:nvSpPr>
          <p:spPr>
            <a:xfrm>
              <a:off x="2211086" y="5846929"/>
              <a:ext cx="2011368" cy="52932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2147893" y="5968572"/>
              <a:ext cx="50263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TextBox 109"/>
            <p:cNvSpPr txBox="1"/>
            <p:nvPr/>
          </p:nvSpPr>
          <p:spPr>
            <a:xfrm rot="21533104">
              <a:off x="2606470" y="5849101"/>
              <a:ext cx="86113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iR-574</a:t>
              </a:r>
            </a:p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3p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 rot="21533104">
              <a:off x="3356312" y="5819251"/>
              <a:ext cx="86113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iR-574</a:t>
              </a:r>
            </a:p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5p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4" name="TextBox 53"/>
          <p:cNvSpPr txBox="1"/>
          <p:nvPr/>
        </p:nvSpPr>
        <p:spPr>
          <a:xfrm>
            <a:off x="1543021" y="2773288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7354751" y="675120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7332131" y="967966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7398197" y="3913829"/>
            <a:ext cx="421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7399647" y="4221149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7317946" y="2117896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7340246" y="1797479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7361998" y="1438661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1632451" y="3969977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7043055" y="5097823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7011550" y="4665727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7633423" y="6325375"/>
            <a:ext cx="421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7683612" y="5675142"/>
            <a:ext cx="421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24"/>
          <p:cNvSpPr txBox="1"/>
          <p:nvPr/>
        </p:nvSpPr>
        <p:spPr>
          <a:xfrm>
            <a:off x="4987064" y="149277"/>
            <a:ext cx="16879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8C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178770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32516" y="4632425"/>
            <a:ext cx="4425347" cy="999272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3"/>
          <a:srcRect t="17335"/>
          <a:stretch/>
        </p:blipFill>
        <p:spPr>
          <a:xfrm flipH="1">
            <a:off x="1140010" y="3197171"/>
            <a:ext cx="4626927" cy="1113796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flipH="1">
            <a:off x="7015673" y="2454246"/>
            <a:ext cx="4442190" cy="1141791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flipH="1">
            <a:off x="1120217" y="665132"/>
            <a:ext cx="4199550" cy="833331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flipH="1">
            <a:off x="7065117" y="3658010"/>
            <a:ext cx="4487903" cy="843487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248" t="57182" r="29286" b="29897"/>
          <a:stretch/>
        </p:blipFill>
        <p:spPr>
          <a:xfrm flipH="1">
            <a:off x="1118769" y="5075747"/>
            <a:ext cx="4626927" cy="1153664"/>
          </a:xfrm>
          <a:prstGeom prst="rect">
            <a:avLst/>
          </a:prstGeom>
        </p:spPr>
      </p:pic>
      <p:pic>
        <p:nvPicPr>
          <p:cNvPr id="91" name="Picture 90"/>
          <p:cNvPicPr>
            <a:picLocks noChangeAspect="1"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8478" t="20069" r="29285" b="72234"/>
          <a:stretch/>
        </p:blipFill>
        <p:spPr>
          <a:xfrm flipH="1">
            <a:off x="1119475" y="4353752"/>
            <a:ext cx="4627789" cy="674886"/>
          </a:xfrm>
          <a:prstGeom prst="rect">
            <a:avLst/>
          </a:prstGeom>
        </p:spPr>
      </p:pic>
      <p:sp>
        <p:nvSpPr>
          <p:cNvPr id="93" name="TextBox 92"/>
          <p:cNvSpPr txBox="1"/>
          <p:nvPr/>
        </p:nvSpPr>
        <p:spPr>
          <a:xfrm>
            <a:off x="1414869" y="4327133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1394617" y="5109246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1368515" y="5531937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4" name="Picture 83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379" t="16632" r="30055" b="75670"/>
          <a:stretch/>
        </p:blipFill>
        <p:spPr>
          <a:xfrm flipH="1">
            <a:off x="6920517" y="669593"/>
            <a:ext cx="4632503" cy="670335"/>
          </a:xfrm>
          <a:prstGeom prst="rect">
            <a:avLst/>
          </a:prstGeom>
        </p:spPr>
      </p:pic>
      <p:pic>
        <p:nvPicPr>
          <p:cNvPr id="73" name="Picture 72"/>
          <p:cNvPicPr>
            <a:picLocks noChangeAspect="1"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578" t="39588" r="29835" b="48728"/>
          <a:stretch/>
        </p:blipFill>
        <p:spPr>
          <a:xfrm flipH="1">
            <a:off x="6965119" y="1375706"/>
            <a:ext cx="4587901" cy="1056833"/>
          </a:xfrm>
          <a:prstGeom prst="rect">
            <a:avLst/>
          </a:prstGeom>
        </p:spPr>
      </p:pic>
      <p:sp>
        <p:nvSpPr>
          <p:cNvPr id="77" name="TextBox 76"/>
          <p:cNvSpPr txBox="1"/>
          <p:nvPr/>
        </p:nvSpPr>
        <p:spPr>
          <a:xfrm>
            <a:off x="7207418" y="2166818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7229718" y="1846401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7251470" y="1487583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 flipH="1">
            <a:off x="7207418" y="5700669"/>
            <a:ext cx="4174857" cy="102669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140010" y="2358636"/>
            <a:ext cx="4146104" cy="808250"/>
          </a:xfrm>
          <a:prstGeom prst="rect">
            <a:avLst/>
          </a:prstGeom>
        </p:spPr>
      </p:pic>
      <p:pic>
        <p:nvPicPr>
          <p:cNvPr id="40" name="Picture 39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131793" y="1534812"/>
            <a:ext cx="4162539" cy="789971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2826010" y="1122806"/>
            <a:ext cx="1703672" cy="3040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TextBox 42"/>
          <p:cNvSpPr txBox="1"/>
          <p:nvPr/>
        </p:nvSpPr>
        <p:spPr>
          <a:xfrm>
            <a:off x="242099" y="990585"/>
            <a:ext cx="9028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DUFS1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Rectangle 43"/>
          <p:cNvSpPr/>
          <p:nvPr/>
        </p:nvSpPr>
        <p:spPr>
          <a:xfrm>
            <a:off x="2917529" y="1983159"/>
            <a:ext cx="858615" cy="18778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TextBox 44"/>
          <p:cNvSpPr txBox="1"/>
          <p:nvPr/>
        </p:nvSpPr>
        <p:spPr>
          <a:xfrm>
            <a:off x="347462" y="1879265"/>
            <a:ext cx="8512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T-ND1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6269237" y="2792058"/>
            <a:ext cx="6735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OX4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Rectangle 46"/>
          <p:cNvSpPr/>
          <p:nvPr/>
        </p:nvSpPr>
        <p:spPr>
          <a:xfrm>
            <a:off x="8694217" y="3035027"/>
            <a:ext cx="1730776" cy="2684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Rectangle 47"/>
          <p:cNvSpPr/>
          <p:nvPr/>
        </p:nvSpPr>
        <p:spPr>
          <a:xfrm>
            <a:off x="8936842" y="3951696"/>
            <a:ext cx="1770955" cy="3314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TextBox 48"/>
          <p:cNvSpPr txBox="1"/>
          <p:nvPr/>
        </p:nvSpPr>
        <p:spPr>
          <a:xfrm>
            <a:off x="6244870" y="4028551"/>
            <a:ext cx="8608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T-CO2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6106362" y="1703868"/>
            <a:ext cx="8624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T-CYB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Rectangle 50"/>
          <p:cNvSpPr/>
          <p:nvPr/>
        </p:nvSpPr>
        <p:spPr>
          <a:xfrm>
            <a:off x="8052342" y="2124140"/>
            <a:ext cx="885837" cy="30605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Rectangle 51"/>
          <p:cNvSpPr/>
          <p:nvPr/>
        </p:nvSpPr>
        <p:spPr>
          <a:xfrm>
            <a:off x="2214016" y="5578312"/>
            <a:ext cx="956214" cy="26037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TextBox 52"/>
          <p:cNvSpPr txBox="1"/>
          <p:nvPr/>
        </p:nvSpPr>
        <p:spPr>
          <a:xfrm>
            <a:off x="397752" y="5468820"/>
            <a:ext cx="7777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TOM2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5999932" y="818445"/>
            <a:ext cx="9428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UQCRC2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Rectangle 55"/>
          <p:cNvSpPr/>
          <p:nvPr/>
        </p:nvSpPr>
        <p:spPr>
          <a:xfrm>
            <a:off x="7962069" y="908535"/>
            <a:ext cx="850940" cy="28967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TextBox 57"/>
          <p:cNvSpPr txBox="1"/>
          <p:nvPr/>
        </p:nvSpPr>
        <p:spPr>
          <a:xfrm>
            <a:off x="504394" y="2556302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DH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Rectangle 58"/>
          <p:cNvSpPr/>
          <p:nvPr/>
        </p:nvSpPr>
        <p:spPr>
          <a:xfrm>
            <a:off x="2917529" y="2883049"/>
            <a:ext cx="832752" cy="2185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" name="TextBox 67"/>
          <p:cNvSpPr txBox="1"/>
          <p:nvPr/>
        </p:nvSpPr>
        <p:spPr>
          <a:xfrm>
            <a:off x="203981" y="3582589"/>
            <a:ext cx="9714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AM210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Rectangle 68"/>
          <p:cNvSpPr/>
          <p:nvPr/>
        </p:nvSpPr>
        <p:spPr>
          <a:xfrm>
            <a:off x="3023213" y="3886567"/>
            <a:ext cx="1825680" cy="3307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TextBox 69"/>
          <p:cNvSpPr txBox="1"/>
          <p:nvPr/>
        </p:nvSpPr>
        <p:spPr>
          <a:xfrm>
            <a:off x="8331735" y="6445804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1559147" y="3754381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1548192" y="3288315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332905" y="4494860"/>
            <a:ext cx="8242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Rectangle 74"/>
          <p:cNvSpPr/>
          <p:nvPr/>
        </p:nvSpPr>
        <p:spPr>
          <a:xfrm>
            <a:off x="2180284" y="4471369"/>
            <a:ext cx="927020" cy="29574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8" name="Rectangle 77"/>
          <p:cNvSpPr/>
          <p:nvPr/>
        </p:nvSpPr>
        <p:spPr>
          <a:xfrm>
            <a:off x="8340654" y="6041375"/>
            <a:ext cx="991728" cy="3314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9" name="TextBox 78"/>
          <p:cNvSpPr txBox="1"/>
          <p:nvPr/>
        </p:nvSpPr>
        <p:spPr>
          <a:xfrm>
            <a:off x="6248663" y="6060126"/>
            <a:ext cx="9276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T-ATP6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Rectangle 81"/>
          <p:cNvSpPr/>
          <p:nvPr/>
        </p:nvSpPr>
        <p:spPr>
          <a:xfrm>
            <a:off x="7098041" y="4859776"/>
            <a:ext cx="1707262" cy="32447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TextBox 82"/>
          <p:cNvSpPr txBox="1"/>
          <p:nvPr/>
        </p:nvSpPr>
        <p:spPr>
          <a:xfrm>
            <a:off x="6228447" y="4841492"/>
            <a:ext cx="7403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TP5B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/>
          <p:cNvSpPr txBox="1"/>
          <p:nvPr/>
        </p:nvSpPr>
        <p:spPr>
          <a:xfrm rot="21533104">
            <a:off x="751373" y="6419236"/>
            <a:ext cx="1418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ample loading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7434782" y="5941953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7465847" y="5667423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3" name="Group 62"/>
          <p:cNvGrpSpPr/>
          <p:nvPr/>
        </p:nvGrpSpPr>
        <p:grpSpPr>
          <a:xfrm>
            <a:off x="2109688" y="6226578"/>
            <a:ext cx="2054240" cy="561963"/>
            <a:chOff x="2187002" y="5814294"/>
            <a:chExt cx="2054240" cy="561963"/>
          </a:xfrm>
        </p:grpSpPr>
        <p:sp>
          <p:nvSpPr>
            <p:cNvPr id="64" name="Rectangle 63"/>
            <p:cNvSpPr/>
            <p:nvPr/>
          </p:nvSpPr>
          <p:spPr>
            <a:xfrm>
              <a:off x="2211086" y="5846929"/>
              <a:ext cx="2011368" cy="52932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2187002" y="5851842"/>
              <a:ext cx="502636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nti-NC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 rot="21533104">
              <a:off x="2611278" y="5849101"/>
              <a:ext cx="851515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nti-574</a:t>
              </a:r>
            </a:p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3p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 rot="21533104">
              <a:off x="3389727" y="5814294"/>
              <a:ext cx="851515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nti-574</a:t>
              </a:r>
            </a:p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5p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5" name="TextBox 84"/>
          <p:cNvSpPr txBox="1"/>
          <p:nvPr/>
        </p:nvSpPr>
        <p:spPr>
          <a:xfrm>
            <a:off x="7244223" y="724042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7221603" y="1016888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7399137" y="3761206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7400930" y="4223342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1487034" y="1044525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1480235" y="797946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1469280" y="620214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7399137" y="2535093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7469628" y="3186122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24"/>
          <p:cNvSpPr txBox="1"/>
          <p:nvPr/>
        </p:nvSpPr>
        <p:spPr>
          <a:xfrm>
            <a:off x="5155962" y="76015"/>
            <a:ext cx="16879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8D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392770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19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60834" y="1107295"/>
            <a:ext cx="2581560" cy="2743200"/>
          </a:xfrm>
          <a:prstGeom prst="rect">
            <a:avLst/>
          </a:prstGeom>
        </p:spPr>
      </p:pic>
      <p:sp>
        <p:nvSpPr>
          <p:cNvPr id="22" name="TextBox 21"/>
          <p:cNvSpPr txBox="1"/>
          <p:nvPr/>
        </p:nvSpPr>
        <p:spPr>
          <a:xfrm>
            <a:off x="4689629" y="808898"/>
            <a:ext cx="10245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Picture 22"/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6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08638" y="3922830"/>
            <a:ext cx="2581559" cy="2743200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13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560834" y="3922830"/>
            <a:ext cx="2581560" cy="2743200"/>
          </a:xfrm>
          <a:prstGeom prst="rect">
            <a:avLst/>
          </a:prstGeom>
        </p:spPr>
      </p:pic>
      <p:sp>
        <p:nvSpPr>
          <p:cNvPr id="27" name="TextBox 26"/>
          <p:cNvSpPr txBox="1"/>
          <p:nvPr/>
        </p:nvSpPr>
        <p:spPr>
          <a:xfrm>
            <a:off x="7096542" y="828425"/>
            <a:ext cx="102813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SO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214156" y="5347705"/>
            <a:ext cx="65916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Picture 29"/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14000"/>
                    </a14:imgEffect>
                  </a14:imgLayer>
                </a14:imgProps>
              </a:ext>
            </a:extLst>
          </a:blip>
          <a:srcRect l="19132" t="39284" r="11933"/>
          <a:stretch/>
        </p:blipFill>
        <p:spPr>
          <a:xfrm>
            <a:off x="3908639" y="1107294"/>
            <a:ext cx="2581559" cy="2743200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3214155" y="2478894"/>
            <a:ext cx="65916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24"/>
          <p:cNvSpPr txBox="1"/>
          <p:nvPr/>
        </p:nvSpPr>
        <p:spPr>
          <a:xfrm>
            <a:off x="5486684" y="367230"/>
            <a:ext cx="16879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8G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8311770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931" t="19107" r="29067" b="69347"/>
          <a:stretch/>
        </p:blipFill>
        <p:spPr>
          <a:xfrm>
            <a:off x="7363431" y="1051014"/>
            <a:ext cx="3993481" cy="857934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67587" y="3782598"/>
            <a:ext cx="4028932" cy="895318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703" t="11409" r="30390" b="76358"/>
          <a:stretch/>
        </p:blipFill>
        <p:spPr>
          <a:xfrm>
            <a:off x="7354001" y="1946383"/>
            <a:ext cx="4019502" cy="961656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773" t="39725" r="28409" b="46804"/>
          <a:stretch/>
        </p:blipFill>
        <p:spPr>
          <a:xfrm>
            <a:off x="7367346" y="5422002"/>
            <a:ext cx="4088847" cy="1135148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775842" y="1044000"/>
            <a:ext cx="4146714" cy="560056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 flipH="1">
            <a:off x="1697806" y="4582597"/>
            <a:ext cx="4117699" cy="610029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389453" y="2949386"/>
            <a:ext cx="4088847" cy="797733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367348" y="4729657"/>
            <a:ext cx="4088847" cy="62838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916" t="32989" r="24992" b="56976"/>
          <a:stretch/>
        </p:blipFill>
        <p:spPr>
          <a:xfrm flipH="1">
            <a:off x="1695029" y="3129156"/>
            <a:ext cx="4116426" cy="717183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 flipH="1">
            <a:off x="1695029" y="3911579"/>
            <a:ext cx="4059833" cy="598049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 flipH="1">
            <a:off x="1722989" y="2419978"/>
            <a:ext cx="4054208" cy="631721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 flipH="1">
            <a:off x="1683305" y="1591721"/>
            <a:ext cx="4178941" cy="785847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1850682" y="1215432"/>
            <a:ext cx="1905974" cy="3040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TextBox 42"/>
          <p:cNvSpPr txBox="1"/>
          <p:nvPr/>
        </p:nvSpPr>
        <p:spPr>
          <a:xfrm>
            <a:off x="953546" y="1195116"/>
            <a:ext cx="9028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DUFS1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Rectangle 43"/>
          <p:cNvSpPr/>
          <p:nvPr/>
        </p:nvSpPr>
        <p:spPr>
          <a:xfrm>
            <a:off x="3689073" y="1873262"/>
            <a:ext cx="1544765" cy="2135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TextBox 44"/>
          <p:cNvSpPr txBox="1"/>
          <p:nvPr/>
        </p:nvSpPr>
        <p:spPr>
          <a:xfrm>
            <a:off x="1193769" y="1740879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D1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6689849" y="3071341"/>
            <a:ext cx="6735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OX4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Rectangle 46"/>
          <p:cNvSpPr/>
          <p:nvPr/>
        </p:nvSpPr>
        <p:spPr>
          <a:xfrm>
            <a:off x="9194372" y="3304577"/>
            <a:ext cx="1764355" cy="24681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Rectangle 47"/>
          <p:cNvSpPr/>
          <p:nvPr/>
        </p:nvSpPr>
        <p:spPr>
          <a:xfrm>
            <a:off x="7803824" y="4020783"/>
            <a:ext cx="1605287" cy="31361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TextBox 48"/>
          <p:cNvSpPr txBox="1"/>
          <p:nvPr/>
        </p:nvSpPr>
        <p:spPr>
          <a:xfrm>
            <a:off x="6729458" y="4026621"/>
            <a:ext cx="6735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OX2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6517544" y="2209309"/>
            <a:ext cx="8624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T-CYB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Rectangle 50"/>
          <p:cNvSpPr/>
          <p:nvPr/>
        </p:nvSpPr>
        <p:spPr>
          <a:xfrm>
            <a:off x="9356387" y="2328839"/>
            <a:ext cx="1592909" cy="30605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Rectangle 51"/>
          <p:cNvSpPr/>
          <p:nvPr/>
        </p:nvSpPr>
        <p:spPr>
          <a:xfrm>
            <a:off x="3738966" y="4854546"/>
            <a:ext cx="1833939" cy="3380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TextBox 52"/>
          <p:cNvSpPr txBox="1"/>
          <p:nvPr/>
        </p:nvSpPr>
        <p:spPr>
          <a:xfrm>
            <a:off x="807243" y="4795278"/>
            <a:ext cx="7777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TOM2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6394524" y="1296279"/>
            <a:ext cx="9428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UQCRC2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Rectangle 55"/>
          <p:cNvSpPr/>
          <p:nvPr/>
        </p:nvSpPr>
        <p:spPr>
          <a:xfrm>
            <a:off x="9332679" y="1588648"/>
            <a:ext cx="1797989" cy="26616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TextBox 57"/>
          <p:cNvSpPr txBox="1"/>
          <p:nvPr/>
        </p:nvSpPr>
        <p:spPr>
          <a:xfrm>
            <a:off x="1038186" y="2535946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DH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Rectangle 58"/>
          <p:cNvSpPr/>
          <p:nvPr/>
        </p:nvSpPr>
        <p:spPr>
          <a:xfrm>
            <a:off x="3608510" y="2702574"/>
            <a:ext cx="1540277" cy="25040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" name="TextBox 67"/>
          <p:cNvSpPr txBox="1"/>
          <p:nvPr/>
        </p:nvSpPr>
        <p:spPr>
          <a:xfrm>
            <a:off x="723545" y="4091630"/>
            <a:ext cx="9714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AM210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Rectangle 68"/>
          <p:cNvSpPr/>
          <p:nvPr/>
        </p:nvSpPr>
        <p:spPr>
          <a:xfrm>
            <a:off x="3579409" y="3974326"/>
            <a:ext cx="1621767" cy="42508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" name="TextBox 73"/>
          <p:cNvSpPr txBox="1"/>
          <p:nvPr/>
        </p:nvSpPr>
        <p:spPr>
          <a:xfrm>
            <a:off x="804219" y="3383410"/>
            <a:ext cx="8242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Rectangle 74"/>
          <p:cNvSpPr/>
          <p:nvPr/>
        </p:nvSpPr>
        <p:spPr>
          <a:xfrm>
            <a:off x="3609896" y="3381241"/>
            <a:ext cx="1647874" cy="27825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" name="TextBox 75"/>
          <p:cNvSpPr txBox="1"/>
          <p:nvPr/>
        </p:nvSpPr>
        <p:spPr>
          <a:xfrm>
            <a:off x="5571315" y="1787195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Rectangle 77"/>
          <p:cNvSpPr/>
          <p:nvPr/>
        </p:nvSpPr>
        <p:spPr>
          <a:xfrm>
            <a:off x="9373419" y="5734135"/>
            <a:ext cx="1685750" cy="28236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9" name="TextBox 78"/>
          <p:cNvSpPr txBox="1"/>
          <p:nvPr/>
        </p:nvSpPr>
        <p:spPr>
          <a:xfrm>
            <a:off x="6504868" y="6016497"/>
            <a:ext cx="9276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T-ATP8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Rectangle 81"/>
          <p:cNvSpPr/>
          <p:nvPr/>
        </p:nvSpPr>
        <p:spPr>
          <a:xfrm>
            <a:off x="9172267" y="5055712"/>
            <a:ext cx="1688940" cy="30232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TextBox 82"/>
          <p:cNvSpPr txBox="1"/>
          <p:nvPr/>
        </p:nvSpPr>
        <p:spPr>
          <a:xfrm>
            <a:off x="6626953" y="4862284"/>
            <a:ext cx="7403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TP5B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11260560" y="1452197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1847802" y="2626785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Straight Connector 22"/>
          <p:cNvCxnSpPr/>
          <p:nvPr/>
        </p:nvCxnSpPr>
        <p:spPr>
          <a:xfrm>
            <a:off x="5449516" y="1937294"/>
            <a:ext cx="15082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TextBox 87"/>
          <p:cNvSpPr txBox="1"/>
          <p:nvPr/>
        </p:nvSpPr>
        <p:spPr>
          <a:xfrm rot="21533104">
            <a:off x="495318" y="6054533"/>
            <a:ext cx="1418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ample loading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1828948" y="2485599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1828948" y="2334605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1849408" y="3247138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1761975" y="4091630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1761299" y="3928195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5657743" y="4457635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5650816" y="4887611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5730837" y="920453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5730837" y="1080501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5743833" y="1239925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11271267" y="5806962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11284853" y="5956732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11284853" y="5475425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11306959" y="4186501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11306959" y="3930266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77" name="TextBox 76"/>
          <p:cNvSpPr txBox="1"/>
          <p:nvPr/>
        </p:nvSpPr>
        <p:spPr>
          <a:xfrm>
            <a:off x="11234540" y="1170191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11260560" y="1003417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11243100" y="2082478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11259320" y="2346553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5" name="Group 24"/>
          <p:cNvGrpSpPr/>
          <p:nvPr/>
        </p:nvGrpSpPr>
        <p:grpSpPr>
          <a:xfrm>
            <a:off x="1925903" y="5871941"/>
            <a:ext cx="3632288" cy="1016528"/>
            <a:chOff x="1714827" y="5301604"/>
            <a:chExt cx="3632288" cy="1016528"/>
          </a:xfrm>
        </p:grpSpPr>
        <p:sp>
          <p:nvSpPr>
            <p:cNvPr id="87" name="Rectangle 86"/>
            <p:cNvSpPr/>
            <p:nvPr/>
          </p:nvSpPr>
          <p:spPr>
            <a:xfrm>
              <a:off x="1735017" y="5349560"/>
              <a:ext cx="3612098" cy="57704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1714827" y="5544380"/>
              <a:ext cx="50263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TextBox 89"/>
            <p:cNvSpPr txBox="1"/>
            <p:nvPr/>
          </p:nvSpPr>
          <p:spPr>
            <a:xfrm rot="21533104">
              <a:off x="2013146" y="5424909"/>
              <a:ext cx="86113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iR-574</a:t>
              </a:r>
            </a:p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3p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TextBox 90"/>
            <p:cNvSpPr txBox="1"/>
            <p:nvPr/>
          </p:nvSpPr>
          <p:spPr>
            <a:xfrm rot="21533104">
              <a:off x="2725280" y="5395059"/>
              <a:ext cx="86113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iR-574</a:t>
              </a:r>
            </a:p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5p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3470520" y="5450925"/>
              <a:ext cx="50263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TextBox 92"/>
            <p:cNvSpPr txBox="1"/>
            <p:nvPr/>
          </p:nvSpPr>
          <p:spPr>
            <a:xfrm rot="21533104">
              <a:off x="3768839" y="5331454"/>
              <a:ext cx="86113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iR-574</a:t>
              </a:r>
            </a:p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3p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TextBox 93"/>
            <p:cNvSpPr txBox="1"/>
            <p:nvPr/>
          </p:nvSpPr>
          <p:spPr>
            <a:xfrm rot="21533104">
              <a:off x="4480973" y="5301604"/>
              <a:ext cx="86113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iR-574</a:t>
              </a:r>
            </a:p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5p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" name="Straight Connector 21"/>
            <p:cNvCxnSpPr/>
            <p:nvPr/>
          </p:nvCxnSpPr>
          <p:spPr>
            <a:xfrm>
              <a:off x="3594449" y="5994166"/>
              <a:ext cx="167836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5" name="TextBox 94"/>
            <p:cNvSpPr txBox="1"/>
            <p:nvPr/>
          </p:nvSpPr>
          <p:spPr>
            <a:xfrm rot="21533104">
              <a:off x="3857692" y="6010355"/>
              <a:ext cx="127098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AM210A OE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5" name="TextBox 24"/>
          <p:cNvSpPr txBox="1"/>
          <p:nvPr/>
        </p:nvSpPr>
        <p:spPr>
          <a:xfrm>
            <a:off x="5260845" y="262560"/>
            <a:ext cx="16879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8I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045992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74</TotalTime>
  <Words>149</Words>
  <Application>Microsoft Office PowerPoint</Application>
  <PresentationFormat>Widescreen</PresentationFormat>
  <Paragraphs>132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UR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u, Jiangbin</dc:creator>
  <cp:lastModifiedBy>Wu, Jiangbin</cp:lastModifiedBy>
  <cp:revision>79</cp:revision>
  <dcterms:created xsi:type="dcterms:W3CDTF">2020-10-20T18:29:31Z</dcterms:created>
  <dcterms:modified xsi:type="dcterms:W3CDTF">2020-10-29T16:19:24Z</dcterms:modified>
</cp:coreProperties>
</file>